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62" d="100"/>
          <a:sy n="162" d="100"/>
        </p:scale>
        <p:origin x="-20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kleftog:Desktop:my_temp_papers:ESA:analysis_V1:Supp_Figure_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kleftog:Desktop:my_temp_papers:ESA:analysis_V1:Supp_Figure_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8741037378847"/>
          <c:y val="0.150179430469617"/>
          <c:w val="0.795628285119571"/>
          <c:h val="0.6159391845229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5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 prstMaterial="metal">
              <a:bevelT w="63500"/>
            </a:sp3d>
          </c:spPr>
          <c:invertIfNegative val="0"/>
          <c:cat>
            <c:strRef>
              <c:f>Sheet1!$A$2:$A$113</c:f>
              <c:strCache>
                <c:ptCount val="112"/>
                <c:pt idx="0">
                  <c:v>epithelial cell of esophagus </c:v>
                </c:pt>
                <c:pt idx="1">
                  <c:v>eye </c:v>
                </c:pt>
                <c:pt idx="2">
                  <c:v>penis </c:v>
                </c:pt>
                <c:pt idx="3">
                  <c:v>skin of body </c:v>
                </c:pt>
                <c:pt idx="4">
                  <c:v>hepatocyte </c:v>
                </c:pt>
                <c:pt idx="5">
                  <c:v>melanocyte </c:v>
                </c:pt>
                <c:pt idx="6">
                  <c:v>fibroblast of the conjuctiva </c:v>
                </c:pt>
                <c:pt idx="7">
                  <c:v>fat cell </c:v>
                </c:pt>
                <c:pt idx="8">
                  <c:v>granulocyte </c:v>
                </c:pt>
                <c:pt idx="9">
                  <c:v>amniotic epithelial cell </c:v>
                </c:pt>
                <c:pt idx="10">
                  <c:v>lymph node </c:v>
                </c:pt>
                <c:pt idx="11">
                  <c:v>endothelial cell of hepatic sinusoid </c:v>
                </c:pt>
                <c:pt idx="12">
                  <c:v>astrocyte </c:v>
                </c:pt>
                <c:pt idx="13">
                  <c:v>blood vessel endothelial cell </c:v>
                </c:pt>
                <c:pt idx="14">
                  <c:v>macrophage </c:v>
                </c:pt>
                <c:pt idx="15">
                  <c:v>brain </c:v>
                </c:pt>
                <c:pt idx="16">
                  <c:v>parotid gland </c:v>
                </c:pt>
                <c:pt idx="17">
                  <c:v>esophagus </c:v>
                </c:pt>
                <c:pt idx="18">
                  <c:v>acinar cell </c:v>
                </c:pt>
                <c:pt idx="19">
                  <c:v>ciliated epithelial cell </c:v>
                </c:pt>
                <c:pt idx="20">
                  <c:v>blood vessel </c:v>
                </c:pt>
                <c:pt idx="21">
                  <c:v>throat </c:v>
                </c:pt>
                <c:pt idx="22">
                  <c:v>cardiac fibroblast </c:v>
                </c:pt>
                <c:pt idx="23">
                  <c:v>small intestine </c:v>
                </c:pt>
                <c:pt idx="24">
                  <c:v>blood </c:v>
                </c:pt>
                <c:pt idx="25">
                  <c:v>fibroblast of tunica adventitia of artery </c:v>
                </c:pt>
                <c:pt idx="26">
                  <c:v>trabecular meshwork cell </c:v>
                </c:pt>
                <c:pt idx="27">
                  <c:v>spinal cord </c:v>
                </c:pt>
                <c:pt idx="28">
                  <c:v>chondrocyte </c:v>
                </c:pt>
                <c:pt idx="29">
                  <c:v>bronchial smooth muscle cell </c:v>
                </c:pt>
                <c:pt idx="30">
                  <c:v>hair follicle cell </c:v>
                </c:pt>
                <c:pt idx="31">
                  <c:v>spleen </c:v>
                </c:pt>
                <c:pt idx="32">
                  <c:v>placenta </c:v>
                </c:pt>
                <c:pt idx="33">
                  <c:v>corneal epithelial cell </c:v>
                </c:pt>
                <c:pt idx="34">
                  <c:v>dendritic cell </c:v>
                </c:pt>
                <c:pt idx="35">
                  <c:v>skin fibroblast </c:v>
                </c:pt>
                <c:pt idx="36">
                  <c:v>epithelial cell of Malassez </c:v>
                </c:pt>
                <c:pt idx="37">
                  <c:v>epithelial cell of prostate </c:v>
                </c:pt>
                <c:pt idx="38">
                  <c:v>reticulocyte </c:v>
                </c:pt>
                <c:pt idx="39">
                  <c:v>cardiac myocyte </c:v>
                </c:pt>
                <c:pt idx="40">
                  <c:v>basophil </c:v>
                </c:pt>
                <c:pt idx="41">
                  <c:v>fibroblast of gingiva </c:v>
                </c:pt>
                <c:pt idx="42">
                  <c:v>enteric smooth muscle cell </c:v>
                </c:pt>
                <c:pt idx="43">
                  <c:v>circulating cell </c:v>
                </c:pt>
                <c:pt idx="44">
                  <c:v>fibroblast of lymphatic vessel </c:v>
                </c:pt>
                <c:pt idx="45">
                  <c:v>iris pigment epithelial cell </c:v>
                </c:pt>
                <c:pt idx="46">
                  <c:v>fibroblast of choroid plexus </c:v>
                </c:pt>
                <c:pt idx="47">
                  <c:v>placental epithelial cell </c:v>
                </c:pt>
                <c:pt idx="48">
                  <c:v>gingival epithelial cell </c:v>
                </c:pt>
                <c:pt idx="49">
                  <c:v>fibroblast of pulmonary artery </c:v>
                </c:pt>
                <c:pt idx="50">
                  <c:v>endothelial cell of lymphatic vessel </c:v>
                </c:pt>
                <c:pt idx="51">
                  <c:v>heart </c:v>
                </c:pt>
                <c:pt idx="52">
                  <c:v>kidney </c:v>
                </c:pt>
                <c:pt idx="53">
                  <c:v>T cell </c:v>
                </c:pt>
                <c:pt idx="54">
                  <c:v>internal male genitalia </c:v>
                </c:pt>
                <c:pt idx="55">
                  <c:v>testis </c:v>
                </c:pt>
                <c:pt idx="56">
                  <c:v>hepatic stellate cell </c:v>
                </c:pt>
                <c:pt idx="57">
                  <c:v>myoblast </c:v>
                </c:pt>
                <c:pt idx="58">
                  <c:v>skeletal muscle tissue </c:v>
                </c:pt>
                <c:pt idx="59">
                  <c:v>submandibular gland </c:v>
                </c:pt>
                <c:pt idx="60">
                  <c:v>liver </c:v>
                </c:pt>
                <c:pt idx="61">
                  <c:v>thyroid gland </c:v>
                </c:pt>
                <c:pt idx="62">
                  <c:v>lung </c:v>
                </c:pt>
                <c:pt idx="63">
                  <c:v>kidney epithelial cell </c:v>
                </c:pt>
                <c:pt idx="64">
                  <c:v>mesenchymal cell </c:v>
                </c:pt>
                <c:pt idx="65">
                  <c:v>lymphocyte of B lineage </c:v>
                </c:pt>
                <c:pt idx="66">
                  <c:v>mammary epithelial cell </c:v>
                </c:pt>
                <c:pt idx="67">
                  <c:v>mast cell </c:v>
                </c:pt>
                <c:pt idx="68">
                  <c:v>meninx </c:v>
                </c:pt>
                <c:pt idx="69">
                  <c:v>smooth muscle cell of the esophagus </c:v>
                </c:pt>
                <c:pt idx="70">
                  <c:v>mesothelial cell </c:v>
                </c:pt>
                <c:pt idx="71">
                  <c:v>natural killer cell </c:v>
                </c:pt>
                <c:pt idx="72">
                  <c:v>keratinocyte </c:v>
                </c:pt>
                <c:pt idx="73">
                  <c:v>female gonad </c:v>
                </c:pt>
                <c:pt idx="74">
                  <c:v>salivary gland </c:v>
                </c:pt>
                <c:pt idx="75">
                  <c:v>retinal pigment epithelial cell </c:v>
                </c:pt>
                <c:pt idx="76">
                  <c:v>neuronal stem cell </c:v>
                </c:pt>
                <c:pt idx="77">
                  <c:v>respiratory epithelial cell </c:v>
                </c:pt>
                <c:pt idx="78">
                  <c:v>lens epithelial cell </c:v>
                </c:pt>
                <c:pt idx="79">
                  <c:v>neutrophil </c:v>
                </c:pt>
                <c:pt idx="80">
                  <c:v>osteoblast </c:v>
                </c:pt>
                <c:pt idx="81">
                  <c:v>pancreas </c:v>
                </c:pt>
                <c:pt idx="82">
                  <c:v>olfactory region </c:v>
                </c:pt>
                <c:pt idx="83">
                  <c:v>keratocyte </c:v>
                </c:pt>
                <c:pt idx="84">
                  <c:v>pericyte cell </c:v>
                </c:pt>
                <c:pt idx="85">
                  <c:v>preadipocyte </c:v>
                </c:pt>
                <c:pt idx="86">
                  <c:v>smooth muscle cell of prostate </c:v>
                </c:pt>
                <c:pt idx="87">
                  <c:v>adipose tissue </c:v>
                </c:pt>
                <c:pt idx="88">
                  <c:v>prostate gland </c:v>
                </c:pt>
                <c:pt idx="89">
                  <c:v>tonsil </c:v>
                </c:pt>
                <c:pt idx="90">
                  <c:v>sensory epithelial cell </c:v>
                </c:pt>
                <c:pt idx="91">
                  <c:v>skeletal muscle cell </c:v>
                </c:pt>
                <c:pt idx="92">
                  <c:v>uterine smooth muscle cell </c:v>
                </c:pt>
                <c:pt idx="93">
                  <c:v>smooth muscle cell of trachea </c:v>
                </c:pt>
                <c:pt idx="94">
                  <c:v>large intestine </c:v>
                </c:pt>
                <c:pt idx="95">
                  <c:v>smooth muscle tissue </c:v>
                </c:pt>
                <c:pt idx="96">
                  <c:v>stomach </c:v>
                </c:pt>
                <c:pt idx="97">
                  <c:v>stromal cell </c:v>
                </c:pt>
                <c:pt idx="98">
                  <c:v>tendon cell </c:v>
                </c:pt>
                <c:pt idx="99">
                  <c:v>thymus </c:v>
                </c:pt>
                <c:pt idx="100">
                  <c:v>tongue </c:v>
                </c:pt>
                <c:pt idx="101">
                  <c:v>umbilical cord </c:v>
                </c:pt>
                <c:pt idx="102">
                  <c:v>uterus </c:v>
                </c:pt>
                <c:pt idx="103">
                  <c:v>urinary bladder </c:v>
                </c:pt>
                <c:pt idx="104">
                  <c:v>urothelial cell </c:v>
                </c:pt>
                <c:pt idx="105">
                  <c:v>vagina </c:v>
                </c:pt>
                <c:pt idx="106">
                  <c:v>vascular associated smooth muscle cell </c:v>
                </c:pt>
                <c:pt idx="107">
                  <c:v>neuron </c:v>
                </c:pt>
                <c:pt idx="108">
                  <c:v>intestinal epithelial cell </c:v>
                </c:pt>
                <c:pt idx="109">
                  <c:v>gallbladder </c:v>
                </c:pt>
                <c:pt idx="110">
                  <c:v>monocyte </c:v>
                </c:pt>
                <c:pt idx="111">
                  <c:v>fibroblast of periodontium </c:v>
                </c:pt>
              </c:strCache>
            </c:strRef>
          </c:cat>
          <c:val>
            <c:numRef>
              <c:f>Sheet1!$C$2:$C$113</c:f>
              <c:numCache>
                <c:formatCode>General</c:formatCode>
                <c:ptCount val="112"/>
                <c:pt idx="0">
                  <c:v>85.70968873075218</c:v>
                </c:pt>
                <c:pt idx="1">
                  <c:v>86.2846253965675</c:v>
                </c:pt>
                <c:pt idx="2">
                  <c:v>74.65690784913548</c:v>
                </c:pt>
                <c:pt idx="3">
                  <c:v>75.22980122352618</c:v>
                </c:pt>
                <c:pt idx="4">
                  <c:v>81.48237524759926</c:v>
                </c:pt>
                <c:pt idx="5">
                  <c:v>85.76481153132</c:v>
                </c:pt>
                <c:pt idx="6">
                  <c:v>81.0705223990322</c:v>
                </c:pt>
                <c:pt idx="7">
                  <c:v>85.01196562412525</c:v>
                </c:pt>
                <c:pt idx="8">
                  <c:v>89.70197151114178</c:v>
                </c:pt>
                <c:pt idx="9">
                  <c:v>85.61870525245523</c:v>
                </c:pt>
                <c:pt idx="10">
                  <c:v>82.11677632075506</c:v>
                </c:pt>
                <c:pt idx="11">
                  <c:v>85.43836879685541</c:v>
                </c:pt>
                <c:pt idx="12">
                  <c:v>85.92798483845252</c:v>
                </c:pt>
                <c:pt idx="13">
                  <c:v>86.68185361174572</c:v>
                </c:pt>
                <c:pt idx="14">
                  <c:v>87.51350435252552</c:v>
                </c:pt>
                <c:pt idx="15">
                  <c:v>85.46133767068598</c:v>
                </c:pt>
                <c:pt idx="16">
                  <c:v>74.44473421997012</c:v>
                </c:pt>
                <c:pt idx="17">
                  <c:v>83.6706531033772</c:v>
                </c:pt>
                <c:pt idx="18">
                  <c:v>83.18481250984</c:v>
                </c:pt>
                <c:pt idx="19">
                  <c:v>84.18079814373013</c:v>
                </c:pt>
                <c:pt idx="20">
                  <c:v>85.1046996520116</c:v>
                </c:pt>
                <c:pt idx="21">
                  <c:v>84.4300579232118</c:v>
                </c:pt>
                <c:pt idx="22">
                  <c:v>85.91787048494208</c:v>
                </c:pt>
                <c:pt idx="23">
                  <c:v>84.12941204563121</c:v>
                </c:pt>
                <c:pt idx="24">
                  <c:v>88.39304886784748</c:v>
                </c:pt>
                <c:pt idx="25">
                  <c:v>85.76433498387602</c:v>
                </c:pt>
                <c:pt idx="26">
                  <c:v>83.35888835055474</c:v>
                </c:pt>
                <c:pt idx="27">
                  <c:v>85.77692797379142</c:v>
                </c:pt>
                <c:pt idx="28">
                  <c:v>84.58867456999958</c:v>
                </c:pt>
                <c:pt idx="29">
                  <c:v>85.8936927214129</c:v>
                </c:pt>
                <c:pt idx="30">
                  <c:v>84.43312492415142</c:v>
                </c:pt>
                <c:pt idx="31">
                  <c:v>86.4235527662401</c:v>
                </c:pt>
                <c:pt idx="32">
                  <c:v>84.2596300810529</c:v>
                </c:pt>
                <c:pt idx="33">
                  <c:v>83.79039770951108</c:v>
                </c:pt>
                <c:pt idx="34">
                  <c:v>88.80307682588445</c:v>
                </c:pt>
                <c:pt idx="35">
                  <c:v>86.92988485942915</c:v>
                </c:pt>
                <c:pt idx="36">
                  <c:v>84.07841858952031</c:v>
                </c:pt>
                <c:pt idx="37">
                  <c:v>84.41218826037362</c:v>
                </c:pt>
                <c:pt idx="38">
                  <c:v>82.98307101228643</c:v>
                </c:pt>
                <c:pt idx="39">
                  <c:v>83.31950338741252</c:v>
                </c:pt>
                <c:pt idx="40">
                  <c:v>90.70050829717428</c:v>
                </c:pt>
                <c:pt idx="41">
                  <c:v>85.7554425468192</c:v>
                </c:pt>
                <c:pt idx="42">
                  <c:v>85.25285013360536</c:v>
                </c:pt>
                <c:pt idx="43">
                  <c:v>87.44403288640058</c:v>
                </c:pt>
                <c:pt idx="44">
                  <c:v>84.19244409558127</c:v>
                </c:pt>
                <c:pt idx="45">
                  <c:v>81.15765328117684</c:v>
                </c:pt>
                <c:pt idx="46">
                  <c:v>84.17938858749838</c:v>
                </c:pt>
                <c:pt idx="47">
                  <c:v>86.00626601594292</c:v>
                </c:pt>
                <c:pt idx="48">
                  <c:v>85.6832217859534</c:v>
                </c:pt>
                <c:pt idx="49">
                  <c:v>83.9206374238161</c:v>
                </c:pt>
                <c:pt idx="50">
                  <c:v>85.00851643631958</c:v>
                </c:pt>
                <c:pt idx="51">
                  <c:v>84.67341784699468</c:v>
                </c:pt>
                <c:pt idx="52">
                  <c:v>83.87039630198684</c:v>
                </c:pt>
                <c:pt idx="53">
                  <c:v>87.15707586054738</c:v>
                </c:pt>
                <c:pt idx="54">
                  <c:v>83.13370986620451</c:v>
                </c:pt>
                <c:pt idx="55">
                  <c:v>80.70106159658545</c:v>
                </c:pt>
                <c:pt idx="56">
                  <c:v>83.6030176860301</c:v>
                </c:pt>
                <c:pt idx="57">
                  <c:v>86.01261801062948</c:v>
                </c:pt>
                <c:pt idx="58">
                  <c:v>82.08009449514122</c:v>
                </c:pt>
                <c:pt idx="59">
                  <c:v>71.11157023445011</c:v>
                </c:pt>
                <c:pt idx="60">
                  <c:v>84.13864991081388</c:v>
                </c:pt>
                <c:pt idx="61">
                  <c:v>84.68644482330141</c:v>
                </c:pt>
                <c:pt idx="62">
                  <c:v>86.86579908578918</c:v>
                </c:pt>
                <c:pt idx="63">
                  <c:v>87.17465455155912</c:v>
                </c:pt>
                <c:pt idx="64">
                  <c:v>87.80059783321738</c:v>
                </c:pt>
                <c:pt idx="65">
                  <c:v>86.6965934591846</c:v>
                </c:pt>
                <c:pt idx="66">
                  <c:v>84.55892515722111</c:v>
                </c:pt>
                <c:pt idx="67">
                  <c:v>87.18843549512631</c:v>
                </c:pt>
                <c:pt idx="68">
                  <c:v>85.3999432548005</c:v>
                </c:pt>
                <c:pt idx="69">
                  <c:v>83.82715743779798</c:v>
                </c:pt>
                <c:pt idx="70">
                  <c:v>85.2964629501763</c:v>
                </c:pt>
                <c:pt idx="71">
                  <c:v>88.492954532486</c:v>
                </c:pt>
                <c:pt idx="72">
                  <c:v>85.02582552002568</c:v>
                </c:pt>
                <c:pt idx="73">
                  <c:v>85.57274429427068</c:v>
                </c:pt>
                <c:pt idx="74">
                  <c:v>82.28378414402002</c:v>
                </c:pt>
                <c:pt idx="75">
                  <c:v>84.74961147777382</c:v>
                </c:pt>
                <c:pt idx="76">
                  <c:v>76.69435000659936</c:v>
                </c:pt>
                <c:pt idx="77">
                  <c:v>86.32356746044658</c:v>
                </c:pt>
                <c:pt idx="78">
                  <c:v>84.41877488637128</c:v>
                </c:pt>
                <c:pt idx="79">
                  <c:v>89.12927354667558</c:v>
                </c:pt>
                <c:pt idx="80">
                  <c:v>84.59308780818351</c:v>
                </c:pt>
                <c:pt idx="81">
                  <c:v>75.4647646734256</c:v>
                </c:pt>
                <c:pt idx="82">
                  <c:v>76.39996199675912</c:v>
                </c:pt>
                <c:pt idx="83">
                  <c:v>81.1793964618425</c:v>
                </c:pt>
                <c:pt idx="84">
                  <c:v>84.1879026681653</c:v>
                </c:pt>
                <c:pt idx="85">
                  <c:v>85.8770650429971</c:v>
                </c:pt>
                <c:pt idx="86">
                  <c:v>84.7113859629935</c:v>
                </c:pt>
                <c:pt idx="87">
                  <c:v>85.06974177714568</c:v>
                </c:pt>
                <c:pt idx="88">
                  <c:v>83.55570499893568</c:v>
                </c:pt>
                <c:pt idx="89">
                  <c:v>85.72224971114722</c:v>
                </c:pt>
                <c:pt idx="90">
                  <c:v>85.5537655988773</c:v>
                </c:pt>
                <c:pt idx="91">
                  <c:v>86.41146912097065</c:v>
                </c:pt>
                <c:pt idx="92">
                  <c:v>83.63030650742313</c:v>
                </c:pt>
                <c:pt idx="93">
                  <c:v>80.50755474971045</c:v>
                </c:pt>
                <c:pt idx="94">
                  <c:v>85.37771173378043</c:v>
                </c:pt>
                <c:pt idx="95">
                  <c:v>80.18320114544197</c:v>
                </c:pt>
                <c:pt idx="96">
                  <c:v>69.04201718697608</c:v>
                </c:pt>
                <c:pt idx="97">
                  <c:v>85.9153895313192</c:v>
                </c:pt>
                <c:pt idx="98">
                  <c:v>83.8976790335405</c:v>
                </c:pt>
                <c:pt idx="99">
                  <c:v>85.61487014859107</c:v>
                </c:pt>
                <c:pt idx="100">
                  <c:v>84.01860731358153</c:v>
                </c:pt>
                <c:pt idx="101">
                  <c:v>74.44699024565522</c:v>
                </c:pt>
                <c:pt idx="102">
                  <c:v>82.83451962960614</c:v>
                </c:pt>
                <c:pt idx="103">
                  <c:v>83.72590622151938</c:v>
                </c:pt>
                <c:pt idx="104">
                  <c:v>83.9758236065758</c:v>
                </c:pt>
                <c:pt idx="105">
                  <c:v>83.53820496584674</c:v>
                </c:pt>
                <c:pt idx="106">
                  <c:v>87.17904727115346</c:v>
                </c:pt>
                <c:pt idx="107">
                  <c:v>79.21573134546311</c:v>
                </c:pt>
                <c:pt idx="108">
                  <c:v>84.60377319096722</c:v>
                </c:pt>
                <c:pt idx="109">
                  <c:v>82.36463231013312</c:v>
                </c:pt>
                <c:pt idx="110">
                  <c:v>89.5670908857661</c:v>
                </c:pt>
                <c:pt idx="111">
                  <c:v>85.781686139857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9165448"/>
        <c:axId val="-2139684424"/>
      </c:barChart>
      <c:catAx>
        <c:axId val="-2139165448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prstClr val="black"/>
                    </a:solidFill>
                    <a:latin typeface="Arial"/>
                    <a:ea typeface="+mn-ea"/>
                    <a:cs typeface="Arial"/>
                  </a:defRPr>
                </a:pPr>
                <a:r>
                  <a:rPr lang="en-US" sz="1200" b="1" i="0" baseline="0" dirty="0" smtClean="0">
                    <a:effectLst/>
                  </a:rPr>
                  <a:t>Different FANTOM5 cell types/tissues</a:t>
                </a:r>
                <a:endParaRPr lang="en-US" sz="1200" dirty="0" smtClean="0">
                  <a:effectLst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prstClr val="black"/>
                    </a:solidFill>
                    <a:latin typeface="Arial"/>
                    <a:ea typeface="+mn-ea"/>
                    <a:cs typeface="Arial"/>
                  </a:defRPr>
                </a:pPr>
                <a:endParaRPr lang="en-US" sz="1400" b="1" dirty="0">
                  <a:latin typeface="Arial"/>
                  <a:cs typeface="Arial"/>
                </a:endParaRPr>
              </a:p>
            </c:rich>
          </c:tx>
          <c:layout>
            <c:manualLayout>
              <c:xMode val="edge"/>
              <c:yMode val="edge"/>
              <c:x val="0.307753115958886"/>
              <c:y val="0.80179287368502"/>
            </c:manualLayout>
          </c:layout>
          <c:overlay val="0"/>
        </c:title>
        <c:numFmt formatCode="General" sourceLinked="0"/>
        <c:majorTickMark val="none"/>
        <c:minorTickMark val="in"/>
        <c:tickLblPos val="none"/>
        <c:crossAx val="-2139684424"/>
        <c:crosses val="autoZero"/>
        <c:auto val="1"/>
        <c:lblAlgn val="ctr"/>
        <c:lblOffset val="100"/>
        <c:noMultiLvlLbl val="0"/>
      </c:catAx>
      <c:valAx>
        <c:axId val="-2139684424"/>
        <c:scaling>
          <c:orientation val="minMax"/>
          <c:max val="100.0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1">
                    <a:latin typeface="Arial"/>
                    <a:cs typeface="Arial"/>
                  </a:defRPr>
                </a:pPr>
                <a:r>
                  <a:rPr lang="en-US" sz="1400" b="1">
                    <a:latin typeface="Arial"/>
                    <a:cs typeface="Arial"/>
                  </a:rPr>
                  <a:t>PPV (%) using mRMR</a:t>
                </a:r>
              </a:p>
            </c:rich>
          </c:tx>
          <c:layout>
            <c:manualLayout>
              <c:xMode val="edge"/>
              <c:yMode val="edge"/>
              <c:x val="0.0365115186072798"/>
              <c:y val="0.18575540851597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400" b="1">
                <a:latin typeface="Arial"/>
                <a:cs typeface="Arial"/>
              </a:defRPr>
            </a:pPr>
            <a:endParaRPr lang="en-US"/>
          </a:p>
        </c:txPr>
        <c:crossAx val="-2139165448"/>
        <c:crosses val="autoZero"/>
        <c:crossBetween val="between"/>
        <c:majorUnit val="20.0"/>
        <c:minorUnit val="0.05"/>
      </c:valAx>
      <c:spPr>
        <a:noFill/>
        <a:ln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0940112207386"/>
          <c:y val="0.0740041612185304"/>
          <c:w val="0.836210691677827"/>
          <c:h val="0.64195190742647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3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 prstMaterial="metal">
              <a:bevelT w="63500"/>
            </a:sp3d>
          </c:spPr>
          <c:invertIfNegative val="0"/>
          <c:cat>
            <c:strRef>
              <c:f>Sheet1!$A$2:$A$113</c:f>
              <c:strCache>
                <c:ptCount val="112"/>
                <c:pt idx="0">
                  <c:v>epithelial cell of esophagus </c:v>
                </c:pt>
                <c:pt idx="1">
                  <c:v>eye </c:v>
                </c:pt>
                <c:pt idx="2">
                  <c:v>penis </c:v>
                </c:pt>
                <c:pt idx="3">
                  <c:v>skin of body </c:v>
                </c:pt>
                <c:pt idx="4">
                  <c:v>hepatocyte </c:v>
                </c:pt>
                <c:pt idx="5">
                  <c:v>melanocyte </c:v>
                </c:pt>
                <c:pt idx="6">
                  <c:v>fibroblast of the conjuctiva </c:v>
                </c:pt>
                <c:pt idx="7">
                  <c:v>fat cell </c:v>
                </c:pt>
                <c:pt idx="8">
                  <c:v>granulocyte </c:v>
                </c:pt>
                <c:pt idx="9">
                  <c:v>amniotic epithelial cell </c:v>
                </c:pt>
                <c:pt idx="10">
                  <c:v>lymph node </c:v>
                </c:pt>
                <c:pt idx="11">
                  <c:v>endothelial cell of hepatic sinusoid </c:v>
                </c:pt>
                <c:pt idx="12">
                  <c:v>astrocyte </c:v>
                </c:pt>
                <c:pt idx="13">
                  <c:v>blood vessel endothelial cell </c:v>
                </c:pt>
                <c:pt idx="14">
                  <c:v>macrophage </c:v>
                </c:pt>
                <c:pt idx="15">
                  <c:v>brain </c:v>
                </c:pt>
                <c:pt idx="16">
                  <c:v>parotid gland </c:v>
                </c:pt>
                <c:pt idx="17">
                  <c:v>esophagus </c:v>
                </c:pt>
                <c:pt idx="18">
                  <c:v>acinar cell </c:v>
                </c:pt>
                <c:pt idx="19">
                  <c:v>ciliated epithelial cell </c:v>
                </c:pt>
                <c:pt idx="20">
                  <c:v>blood vessel </c:v>
                </c:pt>
                <c:pt idx="21">
                  <c:v>throat </c:v>
                </c:pt>
                <c:pt idx="22">
                  <c:v>cardiac fibroblast </c:v>
                </c:pt>
                <c:pt idx="23">
                  <c:v>small intestine </c:v>
                </c:pt>
                <c:pt idx="24">
                  <c:v>blood </c:v>
                </c:pt>
                <c:pt idx="25">
                  <c:v>fibroblast of tunica adventitia of artery </c:v>
                </c:pt>
                <c:pt idx="26">
                  <c:v>trabecular meshwork cell </c:v>
                </c:pt>
                <c:pt idx="27">
                  <c:v>spinal cord </c:v>
                </c:pt>
                <c:pt idx="28">
                  <c:v>chondrocyte </c:v>
                </c:pt>
                <c:pt idx="29">
                  <c:v>bronchial smooth muscle cell </c:v>
                </c:pt>
                <c:pt idx="30">
                  <c:v>hair follicle cell </c:v>
                </c:pt>
                <c:pt idx="31">
                  <c:v>spleen </c:v>
                </c:pt>
                <c:pt idx="32">
                  <c:v>placenta </c:v>
                </c:pt>
                <c:pt idx="33">
                  <c:v>corneal epithelial cell </c:v>
                </c:pt>
                <c:pt idx="34">
                  <c:v>dendritic cell </c:v>
                </c:pt>
                <c:pt idx="35">
                  <c:v>skin fibroblast </c:v>
                </c:pt>
                <c:pt idx="36">
                  <c:v>epithelial cell of Malassez </c:v>
                </c:pt>
                <c:pt idx="37">
                  <c:v>epithelial cell of prostate </c:v>
                </c:pt>
                <c:pt idx="38">
                  <c:v>reticulocyte </c:v>
                </c:pt>
                <c:pt idx="39">
                  <c:v>cardiac myocyte </c:v>
                </c:pt>
                <c:pt idx="40">
                  <c:v>basophil </c:v>
                </c:pt>
                <c:pt idx="41">
                  <c:v>fibroblast of gingiva </c:v>
                </c:pt>
                <c:pt idx="42">
                  <c:v>enteric smooth muscle cell </c:v>
                </c:pt>
                <c:pt idx="43">
                  <c:v>circulating cell </c:v>
                </c:pt>
                <c:pt idx="44">
                  <c:v>fibroblast of lymphatic vessel </c:v>
                </c:pt>
                <c:pt idx="45">
                  <c:v>iris pigment epithelial cell </c:v>
                </c:pt>
                <c:pt idx="46">
                  <c:v>fibroblast of choroid plexus </c:v>
                </c:pt>
                <c:pt idx="47">
                  <c:v>placental epithelial cell </c:v>
                </c:pt>
                <c:pt idx="48">
                  <c:v>gingival epithelial cell </c:v>
                </c:pt>
                <c:pt idx="49">
                  <c:v>fibroblast of pulmonary artery </c:v>
                </c:pt>
                <c:pt idx="50">
                  <c:v>endothelial cell of lymphatic vessel </c:v>
                </c:pt>
                <c:pt idx="51">
                  <c:v>heart </c:v>
                </c:pt>
                <c:pt idx="52">
                  <c:v>kidney </c:v>
                </c:pt>
                <c:pt idx="53">
                  <c:v>T cell </c:v>
                </c:pt>
                <c:pt idx="54">
                  <c:v>internal male genitalia </c:v>
                </c:pt>
                <c:pt idx="55">
                  <c:v>testis </c:v>
                </c:pt>
                <c:pt idx="56">
                  <c:v>hepatic stellate cell </c:v>
                </c:pt>
                <c:pt idx="57">
                  <c:v>myoblast </c:v>
                </c:pt>
                <c:pt idx="58">
                  <c:v>skeletal muscle tissue </c:v>
                </c:pt>
                <c:pt idx="59">
                  <c:v>submandibular gland </c:v>
                </c:pt>
                <c:pt idx="60">
                  <c:v>liver </c:v>
                </c:pt>
                <c:pt idx="61">
                  <c:v>thyroid gland </c:v>
                </c:pt>
                <c:pt idx="62">
                  <c:v>lung </c:v>
                </c:pt>
                <c:pt idx="63">
                  <c:v>kidney epithelial cell </c:v>
                </c:pt>
                <c:pt idx="64">
                  <c:v>mesenchymal cell </c:v>
                </c:pt>
                <c:pt idx="65">
                  <c:v>lymphocyte of B lineage </c:v>
                </c:pt>
                <c:pt idx="66">
                  <c:v>mammary epithelial cell </c:v>
                </c:pt>
                <c:pt idx="67">
                  <c:v>mast cell </c:v>
                </c:pt>
                <c:pt idx="68">
                  <c:v>meninx </c:v>
                </c:pt>
                <c:pt idx="69">
                  <c:v>smooth muscle cell of the esophagus </c:v>
                </c:pt>
                <c:pt idx="70">
                  <c:v>mesothelial cell </c:v>
                </c:pt>
                <c:pt idx="71">
                  <c:v>natural killer cell </c:v>
                </c:pt>
                <c:pt idx="72">
                  <c:v>keratinocyte </c:v>
                </c:pt>
                <c:pt idx="73">
                  <c:v>female gonad </c:v>
                </c:pt>
                <c:pt idx="74">
                  <c:v>salivary gland </c:v>
                </c:pt>
                <c:pt idx="75">
                  <c:v>retinal pigment epithelial cell </c:v>
                </c:pt>
                <c:pt idx="76">
                  <c:v>neuronal stem cell </c:v>
                </c:pt>
                <c:pt idx="77">
                  <c:v>respiratory epithelial cell </c:v>
                </c:pt>
                <c:pt idx="78">
                  <c:v>lens epithelial cell </c:v>
                </c:pt>
                <c:pt idx="79">
                  <c:v>neutrophil </c:v>
                </c:pt>
                <c:pt idx="80">
                  <c:v>osteoblast </c:v>
                </c:pt>
                <c:pt idx="81">
                  <c:v>pancreas </c:v>
                </c:pt>
                <c:pt idx="82">
                  <c:v>olfactory region </c:v>
                </c:pt>
                <c:pt idx="83">
                  <c:v>keratocyte </c:v>
                </c:pt>
                <c:pt idx="84">
                  <c:v>pericyte cell </c:v>
                </c:pt>
                <c:pt idx="85">
                  <c:v>preadipocyte </c:v>
                </c:pt>
                <c:pt idx="86">
                  <c:v>smooth muscle cell of prostate </c:v>
                </c:pt>
                <c:pt idx="87">
                  <c:v>adipose tissue </c:v>
                </c:pt>
                <c:pt idx="88">
                  <c:v>prostate gland </c:v>
                </c:pt>
                <c:pt idx="89">
                  <c:v>tonsil </c:v>
                </c:pt>
                <c:pt idx="90">
                  <c:v>sensory epithelial cell </c:v>
                </c:pt>
                <c:pt idx="91">
                  <c:v>skeletal muscle cell </c:v>
                </c:pt>
                <c:pt idx="92">
                  <c:v>uterine smooth muscle cell </c:v>
                </c:pt>
                <c:pt idx="93">
                  <c:v>smooth muscle cell of trachea </c:v>
                </c:pt>
                <c:pt idx="94">
                  <c:v>large intestine </c:v>
                </c:pt>
                <c:pt idx="95">
                  <c:v>smooth muscle tissue </c:v>
                </c:pt>
                <c:pt idx="96">
                  <c:v>stomach </c:v>
                </c:pt>
                <c:pt idx="97">
                  <c:v>stromal cell </c:v>
                </c:pt>
                <c:pt idx="98">
                  <c:v>tendon cell </c:v>
                </c:pt>
                <c:pt idx="99">
                  <c:v>thymus </c:v>
                </c:pt>
                <c:pt idx="100">
                  <c:v>tongue </c:v>
                </c:pt>
                <c:pt idx="101">
                  <c:v>umbilical cord </c:v>
                </c:pt>
                <c:pt idx="102">
                  <c:v>uterus </c:v>
                </c:pt>
                <c:pt idx="103">
                  <c:v>urinary bladder </c:v>
                </c:pt>
                <c:pt idx="104">
                  <c:v>urothelial cell </c:v>
                </c:pt>
                <c:pt idx="105">
                  <c:v>vagina </c:v>
                </c:pt>
                <c:pt idx="106">
                  <c:v>vascular associated smooth muscle cell </c:v>
                </c:pt>
                <c:pt idx="107">
                  <c:v>neuron </c:v>
                </c:pt>
                <c:pt idx="108">
                  <c:v>intestinal epithelial cell </c:v>
                </c:pt>
                <c:pt idx="109">
                  <c:v>gallbladder </c:v>
                </c:pt>
                <c:pt idx="110">
                  <c:v>monocyte </c:v>
                </c:pt>
                <c:pt idx="111">
                  <c:v>fibroblast of periodontium </c:v>
                </c:pt>
              </c:strCache>
            </c:strRef>
          </c:cat>
          <c:val>
            <c:numRef>
              <c:f>Sheet1!$C$2:$C$113</c:f>
              <c:numCache>
                <c:formatCode>General</c:formatCode>
                <c:ptCount val="112"/>
                <c:pt idx="0">
                  <c:v>83.7743412299001</c:v>
                </c:pt>
                <c:pt idx="1">
                  <c:v>85.46099248936585</c:v>
                </c:pt>
                <c:pt idx="2">
                  <c:v>77.3873141046724</c:v>
                </c:pt>
                <c:pt idx="3">
                  <c:v>75.42291496836902</c:v>
                </c:pt>
                <c:pt idx="4">
                  <c:v>80.777045707007</c:v>
                </c:pt>
                <c:pt idx="5">
                  <c:v>85.02876153156721</c:v>
                </c:pt>
                <c:pt idx="6">
                  <c:v>83.4048621383334</c:v>
                </c:pt>
                <c:pt idx="7">
                  <c:v>87.14943245463425</c:v>
                </c:pt>
                <c:pt idx="8">
                  <c:v>91.18079605149266</c:v>
                </c:pt>
                <c:pt idx="9">
                  <c:v>86.12253461670807</c:v>
                </c:pt>
                <c:pt idx="10">
                  <c:v>80.31102514672878</c:v>
                </c:pt>
                <c:pt idx="11">
                  <c:v>85.9129182772363</c:v>
                </c:pt>
                <c:pt idx="12">
                  <c:v>87.367247304209</c:v>
                </c:pt>
                <c:pt idx="13">
                  <c:v>88.73434805722185</c:v>
                </c:pt>
                <c:pt idx="14">
                  <c:v>89.25390180443281</c:v>
                </c:pt>
                <c:pt idx="15">
                  <c:v>87.13519087785104</c:v>
                </c:pt>
                <c:pt idx="16">
                  <c:v>75.45881334684698</c:v>
                </c:pt>
                <c:pt idx="17">
                  <c:v>84.7889237923823</c:v>
                </c:pt>
                <c:pt idx="18">
                  <c:v>86.03809695636912</c:v>
                </c:pt>
                <c:pt idx="19">
                  <c:v>85.77432640878078</c:v>
                </c:pt>
                <c:pt idx="20">
                  <c:v>86.57693654228538</c:v>
                </c:pt>
                <c:pt idx="21">
                  <c:v>85.61140205470402</c:v>
                </c:pt>
                <c:pt idx="22">
                  <c:v>87.72356269420792</c:v>
                </c:pt>
                <c:pt idx="23">
                  <c:v>84.96500070385838</c:v>
                </c:pt>
                <c:pt idx="24">
                  <c:v>89.94441034097874</c:v>
                </c:pt>
                <c:pt idx="25">
                  <c:v>87.25505321896628</c:v>
                </c:pt>
                <c:pt idx="26">
                  <c:v>84.53683887045068</c:v>
                </c:pt>
                <c:pt idx="27">
                  <c:v>85.16469255396997</c:v>
                </c:pt>
                <c:pt idx="28">
                  <c:v>85.16307493235176</c:v>
                </c:pt>
                <c:pt idx="29">
                  <c:v>85.40708546500356</c:v>
                </c:pt>
                <c:pt idx="30">
                  <c:v>86.66213663716218</c:v>
                </c:pt>
                <c:pt idx="31">
                  <c:v>88.4656019873244</c:v>
                </c:pt>
                <c:pt idx="32">
                  <c:v>85.39681202942631</c:v>
                </c:pt>
                <c:pt idx="33">
                  <c:v>82.46588719722271</c:v>
                </c:pt>
                <c:pt idx="34">
                  <c:v>90.82871257496257</c:v>
                </c:pt>
                <c:pt idx="35">
                  <c:v>88.9271897130526</c:v>
                </c:pt>
                <c:pt idx="36">
                  <c:v>86.9262758262403</c:v>
                </c:pt>
                <c:pt idx="37">
                  <c:v>86.26610463365168</c:v>
                </c:pt>
                <c:pt idx="38">
                  <c:v>82.90876517979432</c:v>
                </c:pt>
                <c:pt idx="39">
                  <c:v>83.5952138549914</c:v>
                </c:pt>
                <c:pt idx="40">
                  <c:v>92.03267753006521</c:v>
                </c:pt>
                <c:pt idx="41">
                  <c:v>87.9505533244823</c:v>
                </c:pt>
                <c:pt idx="42">
                  <c:v>86.73129328399575</c:v>
                </c:pt>
                <c:pt idx="43">
                  <c:v>88.46128793977982</c:v>
                </c:pt>
                <c:pt idx="44">
                  <c:v>86.53696022889762</c:v>
                </c:pt>
                <c:pt idx="45">
                  <c:v>81.36847503685573</c:v>
                </c:pt>
                <c:pt idx="46">
                  <c:v>86.07069126478778</c:v>
                </c:pt>
                <c:pt idx="47">
                  <c:v>86.63622048409982</c:v>
                </c:pt>
                <c:pt idx="48">
                  <c:v>88.43735868462742</c:v>
                </c:pt>
                <c:pt idx="49">
                  <c:v>85.5378712894952</c:v>
                </c:pt>
                <c:pt idx="50">
                  <c:v>85.42389839337392</c:v>
                </c:pt>
                <c:pt idx="51">
                  <c:v>85.63122697376468</c:v>
                </c:pt>
                <c:pt idx="52">
                  <c:v>85.5414987994385</c:v>
                </c:pt>
                <c:pt idx="53">
                  <c:v>89.1039177817797</c:v>
                </c:pt>
                <c:pt idx="54">
                  <c:v>85.12190777204447</c:v>
                </c:pt>
                <c:pt idx="55">
                  <c:v>82.57072725067437</c:v>
                </c:pt>
                <c:pt idx="56">
                  <c:v>85.56327439263632</c:v>
                </c:pt>
                <c:pt idx="57">
                  <c:v>87.76055268096256</c:v>
                </c:pt>
                <c:pt idx="58">
                  <c:v>83.55918081465506</c:v>
                </c:pt>
                <c:pt idx="59">
                  <c:v>78.45416034179072</c:v>
                </c:pt>
                <c:pt idx="60">
                  <c:v>84.9052750396108</c:v>
                </c:pt>
                <c:pt idx="61">
                  <c:v>85.51553418373395</c:v>
                </c:pt>
                <c:pt idx="62">
                  <c:v>88.48571065619412</c:v>
                </c:pt>
                <c:pt idx="63">
                  <c:v>88.2051020053313</c:v>
                </c:pt>
                <c:pt idx="64">
                  <c:v>89.65833525066633</c:v>
                </c:pt>
                <c:pt idx="65">
                  <c:v>88.2104664705329</c:v>
                </c:pt>
                <c:pt idx="66">
                  <c:v>86.0035602342854</c:v>
                </c:pt>
                <c:pt idx="67">
                  <c:v>89.31767887157038</c:v>
                </c:pt>
                <c:pt idx="68">
                  <c:v>87.82922850774568</c:v>
                </c:pt>
                <c:pt idx="69">
                  <c:v>81.77868862779525</c:v>
                </c:pt>
                <c:pt idx="70">
                  <c:v>86.91109781876975</c:v>
                </c:pt>
                <c:pt idx="71">
                  <c:v>89.81191847593736</c:v>
                </c:pt>
                <c:pt idx="72">
                  <c:v>86.87070851742205</c:v>
                </c:pt>
                <c:pt idx="73">
                  <c:v>84.5624405057782</c:v>
                </c:pt>
                <c:pt idx="74">
                  <c:v>81.49528848164082</c:v>
                </c:pt>
                <c:pt idx="75">
                  <c:v>85.57263253274795</c:v>
                </c:pt>
                <c:pt idx="76">
                  <c:v>80.634045666328</c:v>
                </c:pt>
                <c:pt idx="77">
                  <c:v>88.49275283783811</c:v>
                </c:pt>
                <c:pt idx="78">
                  <c:v>85.08919192709318</c:v>
                </c:pt>
                <c:pt idx="79">
                  <c:v>91.00178230745662</c:v>
                </c:pt>
                <c:pt idx="80">
                  <c:v>86.90825720131982</c:v>
                </c:pt>
                <c:pt idx="81">
                  <c:v>75.77904858829578</c:v>
                </c:pt>
                <c:pt idx="82">
                  <c:v>79.59073575702126</c:v>
                </c:pt>
                <c:pt idx="83">
                  <c:v>80.83124341295168</c:v>
                </c:pt>
                <c:pt idx="84">
                  <c:v>85.7134319916984</c:v>
                </c:pt>
                <c:pt idx="85">
                  <c:v>87.73432886795008</c:v>
                </c:pt>
                <c:pt idx="86">
                  <c:v>85.72828988774968</c:v>
                </c:pt>
                <c:pt idx="87">
                  <c:v>86.4870981874724</c:v>
                </c:pt>
                <c:pt idx="88">
                  <c:v>85.5504135439325</c:v>
                </c:pt>
                <c:pt idx="89">
                  <c:v>86.3733826157351</c:v>
                </c:pt>
                <c:pt idx="90">
                  <c:v>87.80820944915726</c:v>
                </c:pt>
                <c:pt idx="91">
                  <c:v>87.601760619863</c:v>
                </c:pt>
                <c:pt idx="92">
                  <c:v>85.17825746050141</c:v>
                </c:pt>
                <c:pt idx="93">
                  <c:v>79.4017546395918</c:v>
                </c:pt>
                <c:pt idx="94">
                  <c:v>85.83787285461473</c:v>
                </c:pt>
                <c:pt idx="95">
                  <c:v>79.25964111049443</c:v>
                </c:pt>
                <c:pt idx="96">
                  <c:v>74.8519764571475</c:v>
                </c:pt>
                <c:pt idx="97">
                  <c:v>88.40868459904022</c:v>
                </c:pt>
                <c:pt idx="98">
                  <c:v>84.5673646336501</c:v>
                </c:pt>
                <c:pt idx="99">
                  <c:v>86.92515272307388</c:v>
                </c:pt>
                <c:pt idx="100">
                  <c:v>83.75945721284258</c:v>
                </c:pt>
                <c:pt idx="101">
                  <c:v>72.25042462494005</c:v>
                </c:pt>
                <c:pt idx="102">
                  <c:v>85.10755493452038</c:v>
                </c:pt>
                <c:pt idx="103">
                  <c:v>85.31289528369278</c:v>
                </c:pt>
                <c:pt idx="104">
                  <c:v>85.67366744941688</c:v>
                </c:pt>
                <c:pt idx="105">
                  <c:v>83.96102804921316</c:v>
                </c:pt>
                <c:pt idx="106">
                  <c:v>89.47458277470598</c:v>
                </c:pt>
                <c:pt idx="107">
                  <c:v>82.06580487057602</c:v>
                </c:pt>
                <c:pt idx="108">
                  <c:v>84.72724152521632</c:v>
                </c:pt>
                <c:pt idx="109">
                  <c:v>85.08188255918591</c:v>
                </c:pt>
                <c:pt idx="110">
                  <c:v>91.86504895541032</c:v>
                </c:pt>
                <c:pt idx="111">
                  <c:v>87.19720312428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7031368"/>
        <c:axId val="2135352888"/>
      </c:barChart>
      <c:catAx>
        <c:axId val="2137031368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prstClr val="black"/>
                    </a:solidFill>
                    <a:latin typeface="Arial"/>
                    <a:ea typeface="+mn-ea"/>
                    <a:cs typeface="Arial"/>
                  </a:defRPr>
                </a:pPr>
                <a:r>
                  <a:rPr lang="en-US" sz="1200" b="1" i="0" baseline="0" dirty="0" smtClean="0">
                    <a:effectLst/>
                  </a:rPr>
                  <a:t>Different FANTOM5 cell types/tissues</a:t>
                </a:r>
                <a:endParaRPr lang="en-US" sz="1200" b="1" dirty="0">
                  <a:latin typeface="Arial"/>
                  <a:cs typeface="Arial"/>
                </a:endParaRPr>
              </a:p>
            </c:rich>
          </c:tx>
          <c:layout>
            <c:manualLayout>
              <c:xMode val="edge"/>
              <c:yMode val="edge"/>
              <c:x val="0.327364942519263"/>
              <c:y val="0.755747645348223"/>
            </c:manualLayout>
          </c:layout>
          <c:overlay val="0"/>
        </c:title>
        <c:numFmt formatCode="General" sourceLinked="0"/>
        <c:majorTickMark val="none"/>
        <c:minorTickMark val="in"/>
        <c:tickLblPos val="none"/>
        <c:crossAx val="2135352888"/>
        <c:crosses val="autoZero"/>
        <c:auto val="1"/>
        <c:lblAlgn val="ctr"/>
        <c:lblOffset val="100"/>
        <c:noMultiLvlLbl val="0"/>
      </c:catAx>
      <c:valAx>
        <c:axId val="2135352888"/>
        <c:scaling>
          <c:orientation val="minMax"/>
          <c:max val="100.0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1">
                    <a:latin typeface="Arial"/>
                    <a:cs typeface="Arial"/>
                  </a:defRPr>
                </a:pPr>
                <a:r>
                  <a:rPr lang="en-US" sz="1400" b="1">
                    <a:latin typeface="Arial"/>
                    <a:cs typeface="Arial"/>
                  </a:rPr>
                  <a:t>PPV (%) using Fisher FS</a:t>
                </a:r>
              </a:p>
            </c:rich>
          </c:tx>
          <c:layout>
            <c:manualLayout>
              <c:xMode val="edge"/>
              <c:yMode val="edge"/>
              <c:x val="0.0334281630887988"/>
              <c:y val="0.082307271865270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400" b="1">
                <a:latin typeface="Arial"/>
                <a:cs typeface="Arial"/>
              </a:defRPr>
            </a:pPr>
            <a:endParaRPr lang="en-US"/>
          </a:p>
        </c:txPr>
        <c:crossAx val="2137031368"/>
        <c:crosses val="autoZero"/>
        <c:crossBetween val="between"/>
        <c:majorUnit val="20.0"/>
        <c:minorUnit val="0.05"/>
      </c:valAx>
      <c:spPr>
        <a:noFill/>
        <a:ln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433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335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269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842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681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924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161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750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234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249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875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C9F7D7-AEC0-A54C-A6CD-29918D81F41B}" type="datetimeFigureOut">
              <a:rPr lang="en-US" smtClean="0"/>
              <a:pPr/>
              <a:t>18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2B879-288E-C347-A240-0517D5400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05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3664306"/>
              </p:ext>
            </p:extLst>
          </p:nvPr>
        </p:nvGraphicFramePr>
        <p:xfrm>
          <a:off x="1302385" y="-21405"/>
          <a:ext cx="6951231" cy="34086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6958784"/>
              </p:ext>
            </p:extLst>
          </p:nvPr>
        </p:nvGraphicFramePr>
        <p:xfrm>
          <a:off x="1302385" y="3271081"/>
          <a:ext cx="6673714" cy="3311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582433" y="1308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A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82433" y="314604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622149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7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C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itrios Kleftogiannis</dc:creator>
  <cp:lastModifiedBy>Dimitrios Kleftogiannis</cp:lastModifiedBy>
  <cp:revision>9</cp:revision>
  <dcterms:created xsi:type="dcterms:W3CDTF">2018-02-26T16:56:40Z</dcterms:created>
  <dcterms:modified xsi:type="dcterms:W3CDTF">2018-11-18T15:52:04Z</dcterms:modified>
</cp:coreProperties>
</file>